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458" r:id="rId2"/>
    <p:sldId id="459" r:id="rId3"/>
    <p:sldId id="460" r:id="rId4"/>
    <p:sldId id="453" r:id="rId5"/>
    <p:sldId id="450" r:id="rId6"/>
    <p:sldId id="456" r:id="rId7"/>
    <p:sldId id="457" r:id="rId8"/>
    <p:sldId id="440" r:id="rId9"/>
    <p:sldId id="461" r:id="rId10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2" autoAdjust="0"/>
    <p:restoredTop sz="89028" autoAdjust="0"/>
  </p:normalViewPr>
  <p:slideViewPr>
    <p:cSldViewPr>
      <p:cViewPr varScale="1">
        <p:scale>
          <a:sx n="82" d="100"/>
          <a:sy n="82" d="100"/>
        </p:scale>
        <p:origin x="1368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Intensity%20of%20GROa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Intensity%20of%20GROa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Intensity%20of%20GROa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Old%20folders\2019\MYT1L_Levon%20edit\Densitometry_Figure%201K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K1/2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G$22</c:f>
              <c:strCache>
                <c:ptCount val="1"/>
                <c:pt idx="0">
                  <c:v>HEK29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23:$I$24</c:f>
                <c:numCache>
                  <c:formatCode>General</c:formatCode>
                  <c:ptCount val="2"/>
                  <c:pt idx="0">
                    <c:v>4.5915832321882712E-2</c:v>
                  </c:pt>
                  <c:pt idx="1">
                    <c:v>6.4875815738587488E-3</c:v>
                  </c:pt>
                </c:numCache>
              </c:numRef>
            </c:plus>
            <c:minus>
              <c:numRef>
                <c:f>Sheet1!$I$23:$I$24</c:f>
                <c:numCache>
                  <c:formatCode>General</c:formatCode>
                  <c:ptCount val="2"/>
                  <c:pt idx="0">
                    <c:v>4.5915832321882712E-2</c:v>
                  </c:pt>
                  <c:pt idx="1">
                    <c:v>6.487581573858748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F$23:$F$24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1!$G$23:$G$24</c:f>
              <c:numCache>
                <c:formatCode>General</c:formatCode>
                <c:ptCount val="2"/>
                <c:pt idx="0">
                  <c:v>0.72629355672902174</c:v>
                </c:pt>
                <c:pt idx="1">
                  <c:v>8.949764458906993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7C-45DC-BD5B-B17785F034F4}"/>
            </c:ext>
          </c:extLst>
        </c:ser>
        <c:ser>
          <c:idx val="1"/>
          <c:order val="1"/>
          <c:tx>
            <c:strRef>
              <c:f>Sheet1!$H$22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J$23:$J$24</c:f>
                <c:numCache>
                  <c:formatCode>General</c:formatCode>
                  <c:ptCount val="2"/>
                  <c:pt idx="0">
                    <c:v>3.1538687654451315E-2</c:v>
                  </c:pt>
                  <c:pt idx="1">
                    <c:v>0.14738305097360008</c:v>
                  </c:pt>
                </c:numCache>
              </c:numRef>
            </c:plus>
            <c:minus>
              <c:numRef>
                <c:f>Sheet1!$J$23:$J$24</c:f>
                <c:numCache>
                  <c:formatCode>General</c:formatCode>
                  <c:ptCount val="2"/>
                  <c:pt idx="0">
                    <c:v>3.1538687654451315E-2</c:v>
                  </c:pt>
                  <c:pt idx="1">
                    <c:v>0.147383050973600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F$23:$F$24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1!$H$23:$H$24</c:f>
              <c:numCache>
                <c:formatCode>General</c:formatCode>
                <c:ptCount val="2"/>
                <c:pt idx="0">
                  <c:v>0.27718746849996079</c:v>
                </c:pt>
                <c:pt idx="1">
                  <c:v>1.14820858189766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E7C-45DC-BD5B-B17785F034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617520"/>
        <c:axId val="444621832"/>
      </c:barChart>
      <c:catAx>
        <c:axId val="444617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21832"/>
        <c:crosses val="autoZero"/>
        <c:auto val="1"/>
        <c:lblAlgn val="ctr"/>
        <c:lblOffset val="100"/>
        <c:noMultiLvlLbl val="0"/>
      </c:catAx>
      <c:valAx>
        <c:axId val="4446218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pERK1/2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175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CL2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L$23</c:f>
              <c:strCache>
                <c:ptCount val="1"/>
                <c:pt idx="0">
                  <c:v>HEK29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N$24:$N$25</c:f>
                <c:numCache>
                  <c:formatCode>General</c:formatCode>
                  <c:ptCount val="2"/>
                  <c:pt idx="0">
                    <c:v>3.1126460617531881E-2</c:v>
                  </c:pt>
                  <c:pt idx="1">
                    <c:v>3.7750898521274195E-2</c:v>
                  </c:pt>
                </c:numCache>
              </c:numRef>
            </c:plus>
            <c:minus>
              <c:numRef>
                <c:f>Sheet2!$N$24:$N$25</c:f>
                <c:numCache>
                  <c:formatCode>General</c:formatCode>
                  <c:ptCount val="2"/>
                  <c:pt idx="0">
                    <c:v>3.1126460617531881E-2</c:v>
                  </c:pt>
                  <c:pt idx="1">
                    <c:v>3.775089852127419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K$24:$K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L$24:$L$25</c:f>
              <c:numCache>
                <c:formatCode>General</c:formatCode>
                <c:ptCount val="2"/>
                <c:pt idx="0">
                  <c:v>1.7049298839408022</c:v>
                </c:pt>
                <c:pt idx="1">
                  <c:v>0.912608352718521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26-4074-A40F-2125EEC73914}"/>
            </c:ext>
          </c:extLst>
        </c:ser>
        <c:ser>
          <c:idx val="1"/>
          <c:order val="1"/>
          <c:tx>
            <c:strRef>
              <c:f>Sheet2!$M$23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Y$23:$Y$24</c:f>
                <c:numCache>
                  <c:formatCode>General</c:formatCode>
                  <c:ptCount val="2"/>
                  <c:pt idx="0">
                    <c:v>1.3115699164416145E-2</c:v>
                  </c:pt>
                  <c:pt idx="1">
                    <c:v>1.7241637034238568E-3</c:v>
                  </c:pt>
                </c:numCache>
              </c:numRef>
            </c:plus>
            <c:minus>
              <c:numRef>
                <c:f>Sheet1!$Y$23:$Y$24</c:f>
                <c:numCache>
                  <c:formatCode>General</c:formatCode>
                  <c:ptCount val="2"/>
                  <c:pt idx="0">
                    <c:v>1.3115699164416145E-2</c:v>
                  </c:pt>
                  <c:pt idx="1">
                    <c:v>1.724163703423856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K$24:$K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M$24:$M$25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526-4074-A40F-2125EEC739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603408"/>
        <c:axId val="444598312"/>
      </c:barChart>
      <c:catAx>
        <c:axId val="4446034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598312"/>
        <c:crosses val="autoZero"/>
        <c:auto val="1"/>
        <c:lblAlgn val="ctr"/>
        <c:lblOffset val="100"/>
        <c:noMultiLvlLbl val="0"/>
      </c:catAx>
      <c:valAx>
        <c:axId val="4445983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BCL2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034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K2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Q$23</c:f>
              <c:strCache>
                <c:ptCount val="1"/>
                <c:pt idx="0">
                  <c:v>HEK29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S$24:$S$25</c:f>
                <c:numCache>
                  <c:formatCode>General</c:formatCode>
                  <c:ptCount val="2"/>
                  <c:pt idx="0">
                    <c:v>4.6760552805665469E-2</c:v>
                  </c:pt>
                  <c:pt idx="1">
                    <c:v>4.306954807673536E-2</c:v>
                  </c:pt>
                </c:numCache>
              </c:numRef>
            </c:plus>
            <c:minus>
              <c:numRef>
                <c:f>Sheet2!$S$24:$S$25</c:f>
                <c:numCache>
                  <c:formatCode>General</c:formatCode>
                  <c:ptCount val="2"/>
                  <c:pt idx="0">
                    <c:v>4.6760552805665469E-2</c:v>
                  </c:pt>
                  <c:pt idx="1">
                    <c:v>4.30695480767353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P$24:$P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Q$24:$Q$25</c:f>
              <c:numCache>
                <c:formatCode>General</c:formatCode>
                <c:ptCount val="2"/>
                <c:pt idx="0">
                  <c:v>0.96924065501741874</c:v>
                </c:pt>
                <c:pt idx="1">
                  <c:v>0.709634476890411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1F4-4C5E-8651-5A106DC55AF0}"/>
            </c:ext>
          </c:extLst>
        </c:ser>
        <c:ser>
          <c:idx val="1"/>
          <c:order val="1"/>
          <c:tx>
            <c:strRef>
              <c:f>Sheet2!$R$23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T$24:$T$25</c:f>
                <c:numCache>
                  <c:formatCode>General</c:formatCode>
                  <c:ptCount val="2"/>
                  <c:pt idx="0">
                    <c:v>1.6361794555355042E-2</c:v>
                  </c:pt>
                  <c:pt idx="1">
                    <c:v>6.5909080887160704E-3</c:v>
                  </c:pt>
                </c:numCache>
              </c:numRef>
            </c:plus>
            <c:minus>
              <c:numRef>
                <c:f>Sheet2!$T$24:$T$25</c:f>
                <c:numCache>
                  <c:formatCode>General</c:formatCode>
                  <c:ptCount val="2"/>
                  <c:pt idx="0">
                    <c:v>1.6361794555355042E-2</c:v>
                  </c:pt>
                  <c:pt idx="1">
                    <c:v>6.590908088716070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P$24:$P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R$24:$R$25</c:f>
              <c:numCache>
                <c:formatCode>General</c:formatCode>
                <c:ptCount val="2"/>
                <c:pt idx="0">
                  <c:v>0.261067630107441</c:v>
                </c:pt>
                <c:pt idx="1">
                  <c:v>0.222662741710368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1F4-4C5E-8651-5A106DC55A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599880"/>
        <c:axId val="444592824"/>
      </c:barChart>
      <c:catAx>
        <c:axId val="4445998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592824"/>
        <c:crosses val="autoZero"/>
        <c:auto val="1"/>
        <c:lblAlgn val="ctr"/>
        <c:lblOffset val="100"/>
        <c:noMultiLvlLbl val="0"/>
      </c:catAx>
      <c:valAx>
        <c:axId val="4445928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CDK2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5998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K4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V$23</c:f>
              <c:strCache>
                <c:ptCount val="1"/>
                <c:pt idx="0">
                  <c:v>HEK29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X$23:$X$24</c:f>
                <c:numCache>
                  <c:formatCode>General</c:formatCode>
                  <c:ptCount val="2"/>
                  <c:pt idx="0">
                    <c:v>2.6751256560059483E-3</c:v>
                  </c:pt>
                  <c:pt idx="1">
                    <c:v>3.4025714272618954E-2</c:v>
                  </c:pt>
                </c:numCache>
              </c:numRef>
            </c:plus>
            <c:minus>
              <c:numRef>
                <c:f>Sheet1!$X$23:$X$24</c:f>
                <c:numCache>
                  <c:formatCode>General</c:formatCode>
                  <c:ptCount val="2"/>
                  <c:pt idx="0">
                    <c:v>2.6751256560059483E-3</c:v>
                  </c:pt>
                  <c:pt idx="1">
                    <c:v>3.402571427261895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U$24:$U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V$24:$V$25</c:f>
              <c:numCache>
                <c:formatCode>General</c:formatCode>
                <c:ptCount val="2"/>
                <c:pt idx="0">
                  <c:v>1.6685795343835548</c:v>
                </c:pt>
                <c:pt idx="1">
                  <c:v>1.32642687354712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C44-458A-86EE-262501E1083D}"/>
            </c:ext>
          </c:extLst>
        </c:ser>
        <c:ser>
          <c:idx val="1"/>
          <c:order val="1"/>
          <c:tx>
            <c:strRef>
              <c:f>Sheet2!$W$23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Y$23:$Y$24</c:f>
                <c:numCache>
                  <c:formatCode>General</c:formatCode>
                  <c:ptCount val="2"/>
                  <c:pt idx="0">
                    <c:v>1.3115699164416145E-2</c:v>
                  </c:pt>
                  <c:pt idx="1">
                    <c:v>1.7241637034238568E-3</c:v>
                  </c:pt>
                </c:numCache>
              </c:numRef>
            </c:plus>
            <c:minus>
              <c:numRef>
                <c:f>Sheet1!$Y$23:$Y$24</c:f>
                <c:numCache>
                  <c:formatCode>General</c:formatCode>
                  <c:ptCount val="2"/>
                  <c:pt idx="0">
                    <c:v>1.3115699164416145E-2</c:v>
                  </c:pt>
                  <c:pt idx="1">
                    <c:v>1.724163703423856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U$24:$U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W$24:$W$25</c:f>
              <c:numCache>
                <c:formatCode>General</c:formatCode>
                <c:ptCount val="2"/>
                <c:pt idx="0">
                  <c:v>0.64808425671220338</c:v>
                </c:pt>
                <c:pt idx="1">
                  <c:v>0.51788164544919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C44-458A-86EE-262501E108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594000"/>
        <c:axId val="444600272"/>
      </c:barChart>
      <c:catAx>
        <c:axId val="444594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00272"/>
        <c:crosses val="autoZero"/>
        <c:auto val="1"/>
        <c:lblAlgn val="ctr"/>
        <c:lblOffset val="100"/>
        <c:noMultiLvlLbl val="0"/>
      </c:catAx>
      <c:valAx>
        <c:axId val="4446002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CDK4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5940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pase 3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A$23</c:f>
              <c:strCache>
                <c:ptCount val="1"/>
                <c:pt idx="0">
                  <c:v>HEK29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AC$24:$AC$25</c:f>
                <c:numCache>
                  <c:formatCode>General</c:formatCode>
                  <c:ptCount val="2"/>
                  <c:pt idx="0">
                    <c:v>2.7056736743221906E-2</c:v>
                  </c:pt>
                  <c:pt idx="1">
                    <c:v>1.0219108176251846E-2</c:v>
                  </c:pt>
                </c:numCache>
              </c:numRef>
            </c:plus>
            <c:minus>
              <c:numRef>
                <c:f>Sheet2!$AC$24:$AC$25</c:f>
                <c:numCache>
                  <c:formatCode>General</c:formatCode>
                  <c:ptCount val="2"/>
                  <c:pt idx="0">
                    <c:v>2.7056736743221906E-2</c:v>
                  </c:pt>
                  <c:pt idx="1">
                    <c:v>1.021910817625184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Z$24:$Z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AA$24:$AA$25</c:f>
              <c:numCache>
                <c:formatCode>General</c:formatCode>
                <c:ptCount val="2"/>
                <c:pt idx="0">
                  <c:v>1.1342091458859038</c:v>
                </c:pt>
                <c:pt idx="1">
                  <c:v>0.915962811196282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88-4902-BFA6-61D41CDEBE85}"/>
            </c:ext>
          </c:extLst>
        </c:ser>
        <c:ser>
          <c:idx val="1"/>
          <c:order val="1"/>
          <c:tx>
            <c:strRef>
              <c:f>Sheet2!$AB$23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AD$24:$AD$25</c:f>
                <c:numCache>
                  <c:formatCode>General</c:formatCode>
                  <c:ptCount val="2"/>
                  <c:pt idx="0">
                    <c:v>7.4380206276496415E-3</c:v>
                  </c:pt>
                  <c:pt idx="1">
                    <c:v>1.2580828908245675E-2</c:v>
                  </c:pt>
                </c:numCache>
              </c:numRef>
            </c:plus>
            <c:minus>
              <c:numRef>
                <c:f>Sheet2!$AD$24:$AD$25</c:f>
                <c:numCache>
                  <c:formatCode>General</c:formatCode>
                  <c:ptCount val="2"/>
                  <c:pt idx="0">
                    <c:v>7.4380206276496415E-3</c:v>
                  </c:pt>
                  <c:pt idx="1">
                    <c:v>1.258082890824567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Z$24:$Z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AB$24:$AB$25</c:f>
              <c:numCache>
                <c:formatCode>General</c:formatCode>
                <c:ptCount val="2"/>
                <c:pt idx="0">
                  <c:v>0.72870309971318015</c:v>
                </c:pt>
                <c:pt idx="1">
                  <c:v>0.605901681470949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E88-4902-BFA6-61D41CDEBE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614776"/>
        <c:axId val="444606152"/>
      </c:barChart>
      <c:catAx>
        <c:axId val="4446147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06152"/>
        <c:crosses val="autoZero"/>
        <c:auto val="1"/>
        <c:lblAlgn val="ctr"/>
        <c:lblOffset val="100"/>
        <c:noMultiLvlLbl val="0"/>
      </c:catAx>
      <c:valAx>
        <c:axId val="4446061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caspase 3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147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lin D1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F$23</c:f>
              <c:strCache>
                <c:ptCount val="1"/>
                <c:pt idx="0">
                  <c:v>HEK29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AH$24:$AH$25</c:f>
                <c:numCache>
                  <c:formatCode>General</c:formatCode>
                  <c:ptCount val="2"/>
                  <c:pt idx="0">
                    <c:v>9.7487071723544698E-3</c:v>
                  </c:pt>
                  <c:pt idx="1">
                    <c:v>2.9979167909333387E-2</c:v>
                  </c:pt>
                </c:numCache>
              </c:numRef>
            </c:plus>
            <c:minus>
              <c:numRef>
                <c:f>Sheet2!$AH$24:$AH$25</c:f>
                <c:numCache>
                  <c:formatCode>General</c:formatCode>
                  <c:ptCount val="2"/>
                  <c:pt idx="0">
                    <c:v>9.7487071723544698E-3</c:v>
                  </c:pt>
                  <c:pt idx="1">
                    <c:v>2.997916790933338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E$24:$AE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AF$24:$AF$25</c:f>
              <c:numCache>
                <c:formatCode>General</c:formatCode>
                <c:ptCount val="2"/>
                <c:pt idx="0">
                  <c:v>0.2692668247253312</c:v>
                </c:pt>
                <c:pt idx="1">
                  <c:v>0.340565443888610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E80-4B0A-95DD-1FBE1FC5187A}"/>
            </c:ext>
          </c:extLst>
        </c:ser>
        <c:ser>
          <c:idx val="1"/>
          <c:order val="1"/>
          <c:tx>
            <c:strRef>
              <c:f>Sheet2!$AG$23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AI$24:$AI$25</c:f>
                <c:numCache>
                  <c:formatCode>General</c:formatCode>
                  <c:ptCount val="2"/>
                  <c:pt idx="0">
                    <c:v>5.1534686280297042E-3</c:v>
                  </c:pt>
                  <c:pt idx="1">
                    <c:v>1.0783617163905296E-2</c:v>
                  </c:pt>
                </c:numCache>
              </c:numRef>
            </c:plus>
            <c:minus>
              <c:numRef>
                <c:f>Sheet2!$AI$24:$AI$25</c:f>
                <c:numCache>
                  <c:formatCode>General</c:formatCode>
                  <c:ptCount val="2"/>
                  <c:pt idx="0">
                    <c:v>5.1534686280297042E-3</c:v>
                  </c:pt>
                  <c:pt idx="1">
                    <c:v>1.078361716390529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E$24:$AE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AG$24:$AG$25</c:f>
              <c:numCache>
                <c:formatCode>General</c:formatCode>
                <c:ptCount val="2"/>
                <c:pt idx="0">
                  <c:v>0.84848467515482318</c:v>
                </c:pt>
                <c:pt idx="1">
                  <c:v>0.459512860188103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E80-4B0A-95DD-1FBE1FC518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604192"/>
        <c:axId val="444606936"/>
      </c:barChart>
      <c:catAx>
        <c:axId val="444604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06936"/>
        <c:crosses val="autoZero"/>
        <c:auto val="1"/>
        <c:lblAlgn val="ctr"/>
        <c:lblOffset val="100"/>
        <c:noMultiLvlLbl val="0"/>
      </c:catAx>
      <c:valAx>
        <c:axId val="444606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cyclin D1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041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K6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K$23</c:f>
              <c:strCache>
                <c:ptCount val="1"/>
                <c:pt idx="0">
                  <c:v>HEK29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AM$24:$AM$25</c:f>
                <c:numCache>
                  <c:formatCode>General</c:formatCode>
                  <c:ptCount val="2"/>
                  <c:pt idx="0">
                    <c:v>3.1728068668218951E-2</c:v>
                  </c:pt>
                  <c:pt idx="1">
                    <c:v>6.7162158393979821E-2</c:v>
                  </c:pt>
                </c:numCache>
              </c:numRef>
            </c:plus>
            <c:minus>
              <c:numRef>
                <c:f>Sheet2!$AM$24:$AM$25</c:f>
                <c:numCache>
                  <c:formatCode>General</c:formatCode>
                  <c:ptCount val="2"/>
                  <c:pt idx="0">
                    <c:v>3.1728068668218951E-2</c:v>
                  </c:pt>
                  <c:pt idx="1">
                    <c:v>6.716215839397982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J$24:$AJ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AK$24:$AK$25</c:f>
              <c:numCache>
                <c:formatCode>General</c:formatCode>
                <c:ptCount val="2"/>
                <c:pt idx="0">
                  <c:v>1.5370124208001599</c:v>
                </c:pt>
                <c:pt idx="1">
                  <c:v>1.43200735246936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8E7-4D8C-B445-4531DA646C9C}"/>
            </c:ext>
          </c:extLst>
        </c:ser>
        <c:ser>
          <c:idx val="1"/>
          <c:order val="1"/>
          <c:tx>
            <c:strRef>
              <c:f>Sheet2!$AL$23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AN$24:$AN$25</c:f>
                <c:numCache>
                  <c:formatCode>General</c:formatCode>
                  <c:ptCount val="2"/>
                  <c:pt idx="0">
                    <c:v>1.6654036166571788E-2</c:v>
                  </c:pt>
                  <c:pt idx="1">
                    <c:v>1.1749393319916122E-2</c:v>
                  </c:pt>
                </c:numCache>
              </c:numRef>
            </c:plus>
            <c:minus>
              <c:numRef>
                <c:f>Sheet2!$AN$24:$AN$25</c:f>
                <c:numCache>
                  <c:formatCode>General</c:formatCode>
                  <c:ptCount val="2"/>
                  <c:pt idx="0">
                    <c:v>1.6654036166571788E-2</c:v>
                  </c:pt>
                  <c:pt idx="1">
                    <c:v>1.174939331991612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J$24:$AJ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AL$24:$AL$25</c:f>
              <c:numCache>
                <c:formatCode>General</c:formatCode>
                <c:ptCount val="2"/>
                <c:pt idx="0">
                  <c:v>0.64364245405823739</c:v>
                </c:pt>
                <c:pt idx="1">
                  <c:v>0.555826376894162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8E7-4D8C-B445-4531DA646C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609288"/>
        <c:axId val="444610856"/>
      </c:barChart>
      <c:catAx>
        <c:axId val="4446092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10856"/>
        <c:crosses val="autoZero"/>
        <c:auto val="1"/>
        <c:lblAlgn val="ctr"/>
        <c:lblOffset val="100"/>
        <c:noMultiLvlLbl val="0"/>
      </c:catAx>
      <c:valAx>
        <c:axId val="4446108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CDK6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092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lin E1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P$23</c:f>
              <c:strCache>
                <c:ptCount val="1"/>
                <c:pt idx="0">
                  <c:v>HEK29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AR$24:$AR$25</c:f>
                <c:numCache>
                  <c:formatCode>General</c:formatCode>
                  <c:ptCount val="2"/>
                  <c:pt idx="0">
                    <c:v>6.9992512937466556E-2</c:v>
                  </c:pt>
                  <c:pt idx="1">
                    <c:v>0.17329911240081339</c:v>
                  </c:pt>
                </c:numCache>
              </c:numRef>
            </c:plus>
            <c:minus>
              <c:numRef>
                <c:f>Sheet2!$AR$24:$AR$25</c:f>
                <c:numCache>
                  <c:formatCode>General</c:formatCode>
                  <c:ptCount val="2"/>
                  <c:pt idx="0">
                    <c:v>6.9992512937466556E-2</c:v>
                  </c:pt>
                  <c:pt idx="1">
                    <c:v>0.173299112400813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O$24:$AO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AP$24:$AP$25</c:f>
              <c:numCache>
                <c:formatCode>General</c:formatCode>
                <c:ptCount val="2"/>
                <c:pt idx="0">
                  <c:v>2.3803089164231133</c:v>
                </c:pt>
                <c:pt idx="1">
                  <c:v>1.9836586835800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2D6-4C48-91C4-9B018F4C7556}"/>
            </c:ext>
          </c:extLst>
        </c:ser>
        <c:ser>
          <c:idx val="1"/>
          <c:order val="1"/>
          <c:tx>
            <c:strRef>
              <c:f>Sheet2!$AQ$23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AS$24:$AS$25</c:f>
                <c:numCache>
                  <c:formatCode>General</c:formatCode>
                  <c:ptCount val="2"/>
                  <c:pt idx="0">
                    <c:v>5.2687790012353623E-2</c:v>
                  </c:pt>
                  <c:pt idx="1">
                    <c:v>7.2107704615590306E-3</c:v>
                  </c:pt>
                </c:numCache>
              </c:numRef>
            </c:plus>
            <c:minus>
              <c:numRef>
                <c:f>Sheet2!$AS$24:$AS$25</c:f>
                <c:numCache>
                  <c:formatCode>General</c:formatCode>
                  <c:ptCount val="2"/>
                  <c:pt idx="0">
                    <c:v>5.2687790012353623E-2</c:v>
                  </c:pt>
                  <c:pt idx="1">
                    <c:v>7.210770461559030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O$24:$AO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AQ$24:$AQ$25</c:f>
              <c:numCache>
                <c:formatCode>General</c:formatCode>
                <c:ptCount val="2"/>
                <c:pt idx="0">
                  <c:v>0.52722244169172161</c:v>
                </c:pt>
                <c:pt idx="1">
                  <c:v>0.877668695057433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2D6-4C48-91C4-9B018F4C75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615560"/>
        <c:axId val="444615952"/>
      </c:barChart>
      <c:catAx>
        <c:axId val="4446155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15952"/>
        <c:crosses val="autoZero"/>
        <c:auto val="1"/>
        <c:lblAlgn val="ctr"/>
        <c:lblOffset val="100"/>
        <c:noMultiLvlLbl val="0"/>
      </c:catAx>
      <c:valAx>
        <c:axId val="4446159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cyclin E1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155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>
                <a:solidFill>
                  <a:sysClr val="windowText" lastClr="000000"/>
                </a:solidFill>
              </a:rPr>
              <a:t>HEK29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EK293'!$C$12:$C$13</c:f>
                <c:numCache>
                  <c:formatCode>General</c:formatCode>
                  <c:ptCount val="2"/>
                  <c:pt idx="0">
                    <c:v>1.3891906834293532E-5</c:v>
                  </c:pt>
                  <c:pt idx="1">
                    <c:v>4.3399915835594606E-5</c:v>
                  </c:pt>
                </c:numCache>
              </c:numRef>
            </c:plus>
            <c:minus>
              <c:numRef>
                <c:f>'HEK293'!$C$12:$C$13</c:f>
                <c:numCache>
                  <c:formatCode>General</c:formatCode>
                  <c:ptCount val="2"/>
                  <c:pt idx="0">
                    <c:v>1.3891906834293532E-5</c:v>
                  </c:pt>
                  <c:pt idx="1">
                    <c:v>4.3399915835594606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EK293'!$A$12:$A$13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'HEK293'!$B$12:$B$13</c:f>
              <c:numCache>
                <c:formatCode>General</c:formatCode>
                <c:ptCount val="2"/>
                <c:pt idx="0">
                  <c:v>1.0077996538624355E-4</c:v>
                </c:pt>
                <c:pt idx="1">
                  <c:v>5.6311308635226991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068-4E83-A4A8-589E2D905E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612816"/>
        <c:axId val="444604584"/>
      </c:barChart>
      <c:catAx>
        <c:axId val="4446128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4604584"/>
        <c:crosses val="autoZero"/>
        <c:auto val="1"/>
        <c:lblAlgn val="ctr"/>
        <c:lblOffset val="100"/>
        <c:noMultiLvlLbl val="0"/>
      </c:catAx>
      <c:valAx>
        <c:axId val="4446045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</a:rPr>
                  <a:t>Relative</a:t>
                </a:r>
                <a:r>
                  <a:rPr lang="en-US" sz="1200" b="1" baseline="0">
                    <a:solidFill>
                      <a:sysClr val="windowText" lastClr="000000"/>
                    </a:solidFill>
                  </a:rPr>
                  <a:t> fluorescence intensity</a:t>
                </a:r>
                <a:endParaRPr lang="en-US" sz="1200" b="1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46128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>
                <a:solidFill>
                  <a:sysClr val="windowText" lastClr="000000"/>
                </a:solidFill>
              </a:rPr>
              <a:t>M059J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EK293'!$C$12:$C$13</c:f>
                <c:numCache>
                  <c:formatCode>General</c:formatCode>
                  <c:ptCount val="2"/>
                  <c:pt idx="0">
                    <c:v>1.3891906834293532E-5</c:v>
                  </c:pt>
                  <c:pt idx="1">
                    <c:v>4.3399915835594606E-5</c:v>
                  </c:pt>
                </c:numCache>
              </c:numRef>
            </c:plus>
            <c:minus>
              <c:numRef>
                <c:f>'HEK293'!$C$12:$C$13</c:f>
                <c:numCache>
                  <c:formatCode>General</c:formatCode>
                  <c:ptCount val="2"/>
                  <c:pt idx="0">
                    <c:v>1.3891906834293532E-5</c:v>
                  </c:pt>
                  <c:pt idx="1">
                    <c:v>4.3399915835594606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059J!$A$12:$A$13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M059J!$B$12:$B$13</c:f>
              <c:numCache>
                <c:formatCode>General</c:formatCode>
                <c:ptCount val="2"/>
                <c:pt idx="0">
                  <c:v>4.3887712876953866E-4</c:v>
                </c:pt>
                <c:pt idx="1">
                  <c:v>5.3091341682612086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E5E-4014-8389-1643271864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613600"/>
        <c:axId val="474245992"/>
      </c:barChart>
      <c:catAx>
        <c:axId val="4446136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4245992"/>
        <c:crosses val="autoZero"/>
        <c:auto val="1"/>
        <c:lblAlgn val="ctr"/>
        <c:lblOffset val="100"/>
        <c:noMultiLvlLbl val="0"/>
      </c:catAx>
      <c:valAx>
        <c:axId val="4742459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</a:rPr>
                  <a:t>Relative</a:t>
                </a:r>
                <a:r>
                  <a:rPr lang="en-US" sz="1200" b="1" baseline="0">
                    <a:solidFill>
                      <a:sysClr val="windowText" lastClr="000000"/>
                    </a:solidFill>
                  </a:rPr>
                  <a:t> fluorescence intensity</a:t>
                </a:r>
                <a:endParaRPr lang="en-US" sz="1200" b="1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46136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>
                <a:solidFill>
                  <a:sysClr val="windowText" lastClr="000000"/>
                </a:solidFill>
              </a:rPr>
              <a:t>M059K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EK293'!$C$12:$C$13</c:f>
                <c:numCache>
                  <c:formatCode>General</c:formatCode>
                  <c:ptCount val="2"/>
                  <c:pt idx="0">
                    <c:v>1.3891906834293532E-5</c:v>
                  </c:pt>
                  <c:pt idx="1">
                    <c:v>4.3399915835594606E-5</c:v>
                  </c:pt>
                </c:numCache>
              </c:numRef>
            </c:plus>
            <c:minus>
              <c:numRef>
                <c:f>'HEK293'!$C$12:$C$13</c:f>
                <c:numCache>
                  <c:formatCode>General</c:formatCode>
                  <c:ptCount val="2"/>
                  <c:pt idx="0">
                    <c:v>1.3891906834293532E-5</c:v>
                  </c:pt>
                  <c:pt idx="1">
                    <c:v>4.3399915835594606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059K!$A$12:$A$13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M059K!$B$12:$B$13</c:f>
              <c:numCache>
                <c:formatCode>General</c:formatCode>
                <c:ptCount val="2"/>
                <c:pt idx="0">
                  <c:v>4.7136256242323116E-4</c:v>
                </c:pt>
                <c:pt idx="1">
                  <c:v>4.39514711488666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FB-4B92-A8F1-F6E17CC6B1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4246384"/>
        <c:axId val="474242464"/>
      </c:barChart>
      <c:catAx>
        <c:axId val="4742463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4242464"/>
        <c:crosses val="autoZero"/>
        <c:auto val="1"/>
        <c:lblAlgn val="ctr"/>
        <c:lblOffset val="100"/>
        <c:noMultiLvlLbl val="0"/>
      </c:catAx>
      <c:valAx>
        <c:axId val="4742424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</a:rPr>
                  <a:t>Relative</a:t>
                </a:r>
                <a:r>
                  <a:rPr lang="en-US" sz="1200" b="1" baseline="0">
                    <a:solidFill>
                      <a:sysClr val="windowText" lastClr="000000"/>
                    </a:solidFill>
                  </a:rPr>
                  <a:t> fluorescence intensity</a:t>
                </a:r>
                <a:endParaRPr lang="en-US" sz="1200" b="1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42463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K1/2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L$22</c:f>
              <c:strCache>
                <c:ptCount val="1"/>
                <c:pt idx="0">
                  <c:v>HEK29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N$23:$N$24</c:f>
                <c:numCache>
                  <c:formatCode>General</c:formatCode>
                  <c:ptCount val="2"/>
                  <c:pt idx="0">
                    <c:v>1.4994614212670803E-2</c:v>
                  </c:pt>
                  <c:pt idx="1">
                    <c:v>3.6652935932762194E-3</c:v>
                  </c:pt>
                </c:numCache>
              </c:numRef>
            </c:plus>
            <c:minus>
              <c:numRef>
                <c:f>Sheet1!$N$23:$N$24</c:f>
                <c:numCache>
                  <c:formatCode>General</c:formatCode>
                  <c:ptCount val="2"/>
                  <c:pt idx="0">
                    <c:v>1.4994614212670803E-2</c:v>
                  </c:pt>
                  <c:pt idx="1">
                    <c:v>3.665293593276219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K$23:$K$24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1!$L$23:$L$24</c:f>
              <c:numCache>
                <c:formatCode>General</c:formatCode>
                <c:ptCount val="2"/>
                <c:pt idx="0">
                  <c:v>0.64162451164639556</c:v>
                </c:pt>
                <c:pt idx="1">
                  <c:v>0.507505760378378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D02-48C2-B80D-E99967DEE124}"/>
            </c:ext>
          </c:extLst>
        </c:ser>
        <c:ser>
          <c:idx val="1"/>
          <c:order val="1"/>
          <c:tx>
            <c:strRef>
              <c:f>Sheet1!$M$22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23:$O$24</c:f>
                <c:numCache>
                  <c:formatCode>General</c:formatCode>
                  <c:ptCount val="2"/>
                  <c:pt idx="0">
                    <c:v>3.1587260679623958E-3</c:v>
                  </c:pt>
                  <c:pt idx="1">
                    <c:v>2.7371202665130833E-2</c:v>
                  </c:pt>
                </c:numCache>
              </c:numRef>
            </c:plus>
            <c:minus>
              <c:numRef>
                <c:f>Sheet1!$O$23:$O$24</c:f>
                <c:numCache>
                  <c:formatCode>General</c:formatCode>
                  <c:ptCount val="2"/>
                  <c:pt idx="0">
                    <c:v>3.1587260679623958E-3</c:v>
                  </c:pt>
                  <c:pt idx="1">
                    <c:v>2.737120266513083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K$23:$K$24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1!$M$23:$M$24</c:f>
              <c:numCache>
                <c:formatCode>General</c:formatCode>
                <c:ptCount val="2"/>
                <c:pt idx="0">
                  <c:v>0.42164948197094415</c:v>
                </c:pt>
                <c:pt idx="1">
                  <c:v>0.366771102122433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D02-48C2-B80D-E99967DEE1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617128"/>
        <c:axId val="444620264"/>
      </c:barChart>
      <c:catAx>
        <c:axId val="4446171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20264"/>
        <c:crosses val="autoZero"/>
        <c:auto val="1"/>
        <c:lblAlgn val="ctr"/>
        <c:lblOffset val="100"/>
        <c:noMultiLvlLbl val="0"/>
      </c:catAx>
      <c:valAx>
        <c:axId val="4446202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ERK1/2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171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KT1/2/3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Q$22</c:f>
              <c:strCache>
                <c:ptCount val="1"/>
                <c:pt idx="0">
                  <c:v>HEK29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N$23:$N$24</c:f>
                <c:numCache>
                  <c:formatCode>General</c:formatCode>
                  <c:ptCount val="2"/>
                  <c:pt idx="0">
                    <c:v>1.4994614212670803E-2</c:v>
                  </c:pt>
                  <c:pt idx="1">
                    <c:v>3.6652935932762194E-3</c:v>
                  </c:pt>
                </c:numCache>
              </c:numRef>
            </c:plus>
            <c:minus>
              <c:numRef>
                <c:f>Sheet1!$N$23:$N$24</c:f>
                <c:numCache>
                  <c:formatCode>General</c:formatCode>
                  <c:ptCount val="2"/>
                  <c:pt idx="0">
                    <c:v>1.4994614212670803E-2</c:v>
                  </c:pt>
                  <c:pt idx="1">
                    <c:v>3.665293593276219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3:$P$24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1!$Q$23:$Q$24</c:f>
              <c:numCache>
                <c:formatCode>General</c:formatCode>
                <c:ptCount val="2"/>
                <c:pt idx="0">
                  <c:v>0.21857369171429383</c:v>
                </c:pt>
                <c:pt idx="1">
                  <c:v>0.835089801604275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EC-477A-BC61-BE31219F6EF2}"/>
            </c:ext>
          </c:extLst>
        </c:ser>
        <c:ser>
          <c:idx val="1"/>
          <c:order val="1"/>
          <c:tx>
            <c:strRef>
              <c:f>Sheet1!$R$22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23:$O$24</c:f>
                <c:numCache>
                  <c:formatCode>General</c:formatCode>
                  <c:ptCount val="2"/>
                  <c:pt idx="0">
                    <c:v>3.1587260679623958E-3</c:v>
                  </c:pt>
                  <c:pt idx="1">
                    <c:v>2.7371202665130833E-2</c:v>
                  </c:pt>
                </c:numCache>
              </c:numRef>
            </c:plus>
            <c:minus>
              <c:numRef>
                <c:f>Sheet1!$O$23:$O$24</c:f>
                <c:numCache>
                  <c:formatCode>General</c:formatCode>
                  <c:ptCount val="2"/>
                  <c:pt idx="0">
                    <c:v>3.1587260679623958E-3</c:v>
                  </c:pt>
                  <c:pt idx="1">
                    <c:v>2.737120266513083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3:$P$24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1!$R$23:$R$24</c:f>
              <c:numCache>
                <c:formatCode>General</c:formatCode>
                <c:ptCount val="2"/>
                <c:pt idx="0">
                  <c:v>0.1120453191676994</c:v>
                </c:pt>
                <c:pt idx="1">
                  <c:v>0.372164686767525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BEC-477A-BC61-BE31219F6E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620656"/>
        <c:axId val="444622224"/>
      </c:barChart>
      <c:catAx>
        <c:axId val="4446206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22224"/>
        <c:crosses val="autoZero"/>
        <c:auto val="1"/>
        <c:lblAlgn val="ctr"/>
        <c:lblOffset val="100"/>
        <c:noMultiLvlLbl val="0"/>
      </c:catAx>
      <c:valAx>
        <c:axId val="4446222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pAKT1/2/3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206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KT1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V$22</c:f>
              <c:strCache>
                <c:ptCount val="1"/>
                <c:pt idx="0">
                  <c:v>HEK29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X$23:$X$24</c:f>
                <c:numCache>
                  <c:formatCode>General</c:formatCode>
                  <c:ptCount val="2"/>
                  <c:pt idx="0">
                    <c:v>2.6751256560059483E-3</c:v>
                  </c:pt>
                  <c:pt idx="1">
                    <c:v>3.4025714272618954E-2</c:v>
                  </c:pt>
                </c:numCache>
              </c:numRef>
            </c:plus>
            <c:minus>
              <c:numRef>
                <c:f>Sheet1!$X$23:$X$24</c:f>
                <c:numCache>
                  <c:formatCode>General</c:formatCode>
                  <c:ptCount val="2"/>
                  <c:pt idx="0">
                    <c:v>2.6751256560059483E-3</c:v>
                  </c:pt>
                  <c:pt idx="1">
                    <c:v>3.402571427261895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U$23:$U$24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1!$V$23:$V$24</c:f>
              <c:numCache>
                <c:formatCode>General</c:formatCode>
                <c:ptCount val="2"/>
                <c:pt idx="0">
                  <c:v>0.72819408325052015</c:v>
                </c:pt>
                <c:pt idx="1">
                  <c:v>1.45251559082648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8BE-49F6-B033-59EA0E2E52DE}"/>
            </c:ext>
          </c:extLst>
        </c:ser>
        <c:ser>
          <c:idx val="1"/>
          <c:order val="1"/>
          <c:tx>
            <c:strRef>
              <c:f>Sheet1!$W$22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Y$23:$Y$24</c:f>
                <c:numCache>
                  <c:formatCode>General</c:formatCode>
                  <c:ptCount val="2"/>
                  <c:pt idx="0">
                    <c:v>1.3115699164416145E-2</c:v>
                  </c:pt>
                  <c:pt idx="1">
                    <c:v>1.7241637034238568E-3</c:v>
                  </c:pt>
                </c:numCache>
              </c:numRef>
            </c:plus>
            <c:minus>
              <c:numRef>
                <c:f>Sheet1!$Y$23:$Y$24</c:f>
                <c:numCache>
                  <c:formatCode>General</c:formatCode>
                  <c:ptCount val="2"/>
                  <c:pt idx="0">
                    <c:v>1.3115699164416145E-2</c:v>
                  </c:pt>
                  <c:pt idx="1">
                    <c:v>1.724163703423856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U$23:$U$24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1!$W$23:$W$24</c:f>
              <c:numCache>
                <c:formatCode>General</c:formatCode>
                <c:ptCount val="2"/>
                <c:pt idx="0">
                  <c:v>0.54394093724945092</c:v>
                </c:pt>
                <c:pt idx="1">
                  <c:v>0.748737241875148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8BE-49F6-B033-59EA0E2E52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623008"/>
        <c:axId val="444623400"/>
      </c:barChart>
      <c:catAx>
        <c:axId val="444623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23400"/>
        <c:crosses val="autoZero"/>
        <c:auto val="1"/>
        <c:lblAlgn val="ctr"/>
        <c:lblOffset val="100"/>
        <c:noMultiLvlLbl val="0"/>
      </c:catAx>
      <c:valAx>
        <c:axId val="4446234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AKT1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230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21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C$23:$AC$24</c:f>
                <c:numCache>
                  <c:formatCode>General</c:formatCode>
                  <c:ptCount val="2"/>
                  <c:pt idx="0">
                    <c:v>6.4705868822549362E-2</c:v>
                  </c:pt>
                  <c:pt idx="1">
                    <c:v>1.4198943494903474E-2</c:v>
                  </c:pt>
                </c:numCache>
              </c:numRef>
            </c:plus>
            <c:minus>
              <c:numRef>
                <c:f>Sheet1!$AC$23:$AC$24</c:f>
                <c:numCache>
                  <c:formatCode>General</c:formatCode>
                  <c:ptCount val="2"/>
                  <c:pt idx="0">
                    <c:v>6.4705868822549362E-2</c:v>
                  </c:pt>
                  <c:pt idx="1">
                    <c:v>1.419894349490347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Z$23:$Z$24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1!$AA$23:$AA$24</c:f>
              <c:numCache>
                <c:formatCode>General</c:formatCode>
                <c:ptCount val="2"/>
                <c:pt idx="0">
                  <c:v>1.0650756542778879</c:v>
                </c:pt>
                <c:pt idx="1">
                  <c:v>0.586641460859827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08-4491-88AA-04C84BECF3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601448"/>
        <c:axId val="444598704"/>
      </c:barChart>
      <c:catAx>
        <c:axId val="4446014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EK293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598704"/>
        <c:crosses val="autoZero"/>
        <c:auto val="1"/>
        <c:lblAlgn val="ctr"/>
        <c:lblOffset val="100"/>
        <c:noMultiLvlLbl val="0"/>
      </c:catAx>
      <c:valAx>
        <c:axId val="4445987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p21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014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21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A$42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C$43:$AC$44</c:f>
                <c:numCache>
                  <c:formatCode>General</c:formatCode>
                  <c:ptCount val="2"/>
                  <c:pt idx="0">
                    <c:v>2.8430905089357758E-3</c:v>
                  </c:pt>
                  <c:pt idx="1">
                    <c:v>0</c:v>
                  </c:pt>
                </c:numCache>
              </c:numRef>
            </c:plus>
            <c:minus>
              <c:numRef>
                <c:f>Sheet1!$AC$43:$AC$44</c:f>
                <c:numCache>
                  <c:formatCode>General</c:formatCode>
                  <c:ptCount val="2"/>
                  <c:pt idx="0">
                    <c:v>2.8430905089357758E-3</c:v>
                  </c:pt>
                  <c:pt idx="1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Z$43:$Z$44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1!$AA$43:$AA$44</c:f>
              <c:numCache>
                <c:formatCode>General</c:formatCode>
                <c:ptCount val="2"/>
                <c:pt idx="0">
                  <c:v>3.9376569741802044E-2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79-40AE-86F0-817975E899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594392"/>
        <c:axId val="444602232"/>
      </c:barChart>
      <c:catAx>
        <c:axId val="4445943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059K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02232"/>
        <c:crosses val="autoZero"/>
        <c:auto val="1"/>
        <c:lblAlgn val="ctr"/>
        <c:lblOffset val="100"/>
        <c:noMultiLvlLbl val="0"/>
      </c:catAx>
      <c:valAx>
        <c:axId val="4446022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p21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5943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27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F$22</c:f>
              <c:strCache>
                <c:ptCount val="1"/>
                <c:pt idx="0">
                  <c:v>HEK29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H$23:$AH$24</c:f>
                <c:numCache>
                  <c:formatCode>General</c:formatCode>
                  <c:ptCount val="2"/>
                  <c:pt idx="0">
                    <c:v>1.1446726030000848E-2</c:v>
                  </c:pt>
                  <c:pt idx="1">
                    <c:v>9.5862246916205672E-3</c:v>
                  </c:pt>
                </c:numCache>
              </c:numRef>
            </c:plus>
            <c:minus>
              <c:numRef>
                <c:f>Sheet1!$AH$23:$AH$24</c:f>
                <c:numCache>
                  <c:formatCode>General</c:formatCode>
                  <c:ptCount val="2"/>
                  <c:pt idx="0">
                    <c:v>1.1446726030000848E-2</c:v>
                  </c:pt>
                  <c:pt idx="1">
                    <c:v>9.586224691620567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E$23:$AE$24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1!$AF$23:$AF$24</c:f>
              <c:numCache>
                <c:formatCode>General</c:formatCode>
                <c:ptCount val="2"/>
                <c:pt idx="0">
                  <c:v>0.74054871320098759</c:v>
                </c:pt>
                <c:pt idx="1">
                  <c:v>0.564745996138711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48-4272-B7B6-1320E6E9352D}"/>
            </c:ext>
          </c:extLst>
        </c:ser>
        <c:ser>
          <c:idx val="1"/>
          <c:order val="1"/>
          <c:tx>
            <c:strRef>
              <c:f>Sheet1!$AG$22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I$23:$AI$24</c:f>
                <c:numCache>
                  <c:formatCode>General</c:formatCode>
                  <c:ptCount val="2"/>
                  <c:pt idx="0">
                    <c:v>8.7649001027694275E-3</c:v>
                  </c:pt>
                  <c:pt idx="1">
                    <c:v>8.3835431818186125E-3</c:v>
                  </c:pt>
                </c:numCache>
              </c:numRef>
            </c:plus>
            <c:minus>
              <c:numRef>
                <c:f>Sheet1!$AI$23:$AI$24</c:f>
                <c:numCache>
                  <c:formatCode>General</c:formatCode>
                  <c:ptCount val="2"/>
                  <c:pt idx="0">
                    <c:v>8.7649001027694275E-3</c:v>
                  </c:pt>
                  <c:pt idx="1">
                    <c:v>8.383543181818612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E$23:$AE$24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1!$AG$23:$AG$24</c:f>
              <c:numCache>
                <c:formatCode>General</c:formatCode>
                <c:ptCount val="2"/>
                <c:pt idx="0">
                  <c:v>5.6784502598163082E-2</c:v>
                </c:pt>
                <c:pt idx="1">
                  <c:v>8.694650665374549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748-4272-B7B6-1320E6E935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592432"/>
        <c:axId val="444601840"/>
      </c:barChart>
      <c:catAx>
        <c:axId val="4445924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01840"/>
        <c:crosses val="autoZero"/>
        <c:auto val="1"/>
        <c:lblAlgn val="ctr"/>
        <c:lblOffset val="100"/>
        <c:noMultiLvlLbl val="0"/>
      </c:catAx>
      <c:valAx>
        <c:axId val="4446018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p27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5924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X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K$22</c:f>
              <c:strCache>
                <c:ptCount val="1"/>
                <c:pt idx="0">
                  <c:v>HEK29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X$23:$X$24</c:f>
                <c:numCache>
                  <c:formatCode>General</c:formatCode>
                  <c:ptCount val="2"/>
                  <c:pt idx="0">
                    <c:v>2.6751256560059483E-3</c:v>
                  </c:pt>
                  <c:pt idx="1">
                    <c:v>3.4025714272618954E-2</c:v>
                  </c:pt>
                </c:numCache>
              </c:numRef>
            </c:plus>
            <c:minus>
              <c:numRef>
                <c:f>Sheet1!$X$23:$X$24</c:f>
                <c:numCache>
                  <c:formatCode>General</c:formatCode>
                  <c:ptCount val="2"/>
                  <c:pt idx="0">
                    <c:v>2.6751256560059483E-3</c:v>
                  </c:pt>
                  <c:pt idx="1">
                    <c:v>3.402571427261895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J$23:$AJ$24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1!$AK$23:$AK$24</c:f>
              <c:numCache>
                <c:formatCode>General</c:formatCode>
                <c:ptCount val="2"/>
                <c:pt idx="0">
                  <c:v>0.37662540801545957</c:v>
                </c:pt>
                <c:pt idx="1">
                  <c:v>0.692486866526654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9A-4FE1-AE1E-0E48D4262F48}"/>
            </c:ext>
          </c:extLst>
        </c:ser>
        <c:ser>
          <c:idx val="1"/>
          <c:order val="1"/>
          <c:tx>
            <c:strRef>
              <c:f>Sheet1!$AL$22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Y$23:$Y$24</c:f>
                <c:numCache>
                  <c:formatCode>General</c:formatCode>
                  <c:ptCount val="2"/>
                  <c:pt idx="0">
                    <c:v>1.3115699164416145E-2</c:v>
                  </c:pt>
                  <c:pt idx="1">
                    <c:v>1.7241637034238568E-3</c:v>
                  </c:pt>
                </c:numCache>
              </c:numRef>
            </c:plus>
            <c:minus>
              <c:numRef>
                <c:f>Sheet1!$Y$23:$Y$24</c:f>
                <c:numCache>
                  <c:formatCode>General</c:formatCode>
                  <c:ptCount val="2"/>
                  <c:pt idx="0">
                    <c:v>1.3115699164416145E-2</c:v>
                  </c:pt>
                  <c:pt idx="1">
                    <c:v>1.724163703423856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J$23:$AJ$24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1!$AL$23:$AL$24</c:f>
              <c:numCache>
                <c:formatCode>General</c:formatCode>
                <c:ptCount val="2"/>
                <c:pt idx="0">
                  <c:v>0.33012826543646251</c:v>
                </c:pt>
                <c:pt idx="1">
                  <c:v>0.273401560799808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89A-4FE1-AE1E-0E48D4262F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597528"/>
        <c:axId val="444597920"/>
      </c:barChart>
      <c:catAx>
        <c:axId val="444597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597920"/>
        <c:crosses val="autoZero"/>
        <c:auto val="1"/>
        <c:lblAlgn val="ctr"/>
        <c:lblOffset val="100"/>
        <c:noMultiLvlLbl val="0"/>
      </c:catAx>
      <c:valAx>
        <c:axId val="4445979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s of BAX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5975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lin A2_Act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G$23</c:f>
              <c:strCache>
                <c:ptCount val="1"/>
                <c:pt idx="0">
                  <c:v>HEK29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I$24:$I$25</c:f>
                <c:numCache>
                  <c:formatCode>General</c:formatCode>
                  <c:ptCount val="2"/>
                  <c:pt idx="0">
                    <c:v>1.0392918829730164E-2</c:v>
                  </c:pt>
                  <c:pt idx="1">
                    <c:v>7.466450808518192E-3</c:v>
                  </c:pt>
                </c:numCache>
              </c:numRef>
            </c:plus>
            <c:minus>
              <c:numRef>
                <c:f>Sheet2!$I$24:$I$25</c:f>
                <c:numCache>
                  <c:formatCode>General</c:formatCode>
                  <c:ptCount val="2"/>
                  <c:pt idx="0">
                    <c:v>1.0392918829730164E-2</c:v>
                  </c:pt>
                  <c:pt idx="1">
                    <c:v>7.46645080851819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F$24:$F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G$24:$G$25</c:f>
              <c:numCache>
                <c:formatCode>General</c:formatCode>
                <c:ptCount val="2"/>
                <c:pt idx="0">
                  <c:v>0.54312404904146339</c:v>
                </c:pt>
                <c:pt idx="1">
                  <c:v>0.31310432244457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2F0-4A9D-A3BD-A14350F38F0D}"/>
            </c:ext>
          </c:extLst>
        </c:ser>
        <c:ser>
          <c:idx val="1"/>
          <c:order val="1"/>
          <c:tx>
            <c:strRef>
              <c:f>Sheet2!$H$23</c:f>
              <c:strCache>
                <c:ptCount val="1"/>
                <c:pt idx="0">
                  <c:v>M059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J$24:$J$25</c:f>
                <c:numCache>
                  <c:formatCode>General</c:formatCode>
                  <c:ptCount val="2"/>
                  <c:pt idx="0">
                    <c:v>2.075447525318375E-3</c:v>
                  </c:pt>
                  <c:pt idx="1">
                    <c:v>4.0886115521995515E-3</c:v>
                  </c:pt>
                </c:numCache>
              </c:numRef>
            </c:plus>
            <c:minus>
              <c:numRef>
                <c:f>Sheet2!$J$24:$J$25</c:f>
                <c:numCache>
                  <c:formatCode>General</c:formatCode>
                  <c:ptCount val="2"/>
                  <c:pt idx="0">
                    <c:v>2.075447525318375E-3</c:v>
                  </c:pt>
                  <c:pt idx="1">
                    <c:v>4.088611552199551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F$24:$F$25</c:f>
              <c:strCache>
                <c:ptCount val="2"/>
                <c:pt idx="0">
                  <c:v>GFP</c:v>
                </c:pt>
                <c:pt idx="1">
                  <c:v>MYT1L</c:v>
                </c:pt>
              </c:strCache>
            </c:strRef>
          </c:cat>
          <c:val>
            <c:numRef>
              <c:f>Sheet2!$H$24:$H$25</c:f>
              <c:numCache>
                <c:formatCode>General</c:formatCode>
                <c:ptCount val="2"/>
                <c:pt idx="0">
                  <c:v>9.3514793361118342E-2</c:v>
                </c:pt>
                <c:pt idx="1">
                  <c:v>7.396921778613106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2F0-4A9D-A3BD-A14350F38F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600664"/>
        <c:axId val="444602624"/>
      </c:barChart>
      <c:catAx>
        <c:axId val="4446006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02624"/>
        <c:crosses val="autoZero"/>
        <c:auto val="1"/>
        <c:lblAlgn val="ctr"/>
        <c:lblOffset val="100"/>
        <c:noMultiLvlLbl val="0"/>
      </c:catAx>
      <c:valAx>
        <c:axId val="4446026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evel of cyclin A2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46006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07C556-7A04-424C-9B4D-4BC065385098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4463" y="1162050"/>
            <a:ext cx="41814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9D84A9-0774-4B71-BC15-D052DB57A2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0942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84F3A-ABEC-470D-B9A1-D066C3F40C84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E1468-EDA6-4D53-804A-705D3B7B2F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84F3A-ABEC-470D-B9A1-D066C3F40C84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E1468-EDA6-4D53-804A-705D3B7B2F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84F3A-ABEC-470D-B9A1-D066C3F40C84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E1468-EDA6-4D53-804A-705D3B7B2F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84F3A-ABEC-470D-B9A1-D066C3F40C84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E1468-EDA6-4D53-804A-705D3B7B2F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84F3A-ABEC-470D-B9A1-D066C3F40C84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E1468-EDA6-4D53-804A-705D3B7B2F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84F3A-ABEC-470D-B9A1-D066C3F40C84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E1468-EDA6-4D53-804A-705D3B7B2F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84F3A-ABEC-470D-B9A1-D066C3F40C84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E1468-EDA6-4D53-804A-705D3B7B2F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84F3A-ABEC-470D-B9A1-D066C3F40C84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E1468-EDA6-4D53-804A-705D3B7B2F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84F3A-ABEC-470D-B9A1-D066C3F40C84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E1468-EDA6-4D53-804A-705D3B7B2F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84F3A-ABEC-470D-B9A1-D066C3F40C84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E1468-EDA6-4D53-804A-705D3B7B2F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84F3A-ABEC-470D-B9A1-D066C3F40C84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E1468-EDA6-4D53-804A-705D3B7B2F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884F3A-ABEC-470D-B9A1-D066C3F40C84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BE1468-EDA6-4D53-804A-705D3B7B2F5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8.xml"/><Relationship Id="rId2" Type="http://schemas.openxmlformats.org/officeDocument/2006/relationships/chart" Target="../charts/chart17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9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/>
        </p:nvGraphicFramePr>
        <p:xfrm>
          <a:off x="91440" y="347472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874520" y="2103120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154936" y="618744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952744" y="6455664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1</a:t>
            </a:r>
          </a:p>
        </p:txBody>
      </p:sp>
      <p:graphicFrame>
        <p:nvGraphicFramePr>
          <p:cNvPr id="6" name="Chart 5"/>
          <p:cNvGraphicFramePr>
            <a:graphicFrameLocks/>
          </p:cNvGraphicFramePr>
          <p:nvPr/>
        </p:nvGraphicFramePr>
        <p:xfrm>
          <a:off x="2834640" y="347472"/>
          <a:ext cx="275748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4620768" y="96316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graphicFrame>
        <p:nvGraphicFramePr>
          <p:cNvPr id="8" name="Chart 7"/>
          <p:cNvGraphicFramePr>
            <a:graphicFrameLocks/>
          </p:cNvGraphicFramePr>
          <p:nvPr/>
        </p:nvGraphicFramePr>
        <p:xfrm>
          <a:off x="5598141" y="338328"/>
          <a:ext cx="27622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7397496" y="61264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680960" y="143560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graphicFrame>
        <p:nvGraphicFramePr>
          <p:cNvPr id="11" name="Chart 10"/>
          <p:cNvGraphicFramePr>
            <a:graphicFrameLocks/>
          </p:cNvGraphicFramePr>
          <p:nvPr/>
        </p:nvGraphicFramePr>
        <p:xfrm>
          <a:off x="84296" y="3099816"/>
          <a:ext cx="275748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880616" y="338023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164080" y="414832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graphicFrame>
        <p:nvGraphicFramePr>
          <p:cNvPr id="14" name="Chart 13"/>
          <p:cNvGraphicFramePr>
            <a:graphicFrameLocks/>
          </p:cNvGraphicFramePr>
          <p:nvPr/>
        </p:nvGraphicFramePr>
        <p:xfrm>
          <a:off x="2989421" y="3142714"/>
          <a:ext cx="244792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/>
        </p:nvGraphicFramePr>
        <p:xfrm>
          <a:off x="5750541" y="3142714"/>
          <a:ext cx="24574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4693920" y="4145280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7458456" y="5035296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18062032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952744" y="6455664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2</a:t>
            </a:r>
          </a:p>
        </p:txBody>
      </p:sp>
      <p:graphicFrame>
        <p:nvGraphicFramePr>
          <p:cNvPr id="18" name="Chart 17"/>
          <p:cNvGraphicFramePr>
            <a:graphicFrameLocks/>
          </p:cNvGraphicFramePr>
          <p:nvPr/>
        </p:nvGraphicFramePr>
        <p:xfrm>
          <a:off x="81915" y="338328"/>
          <a:ext cx="27622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880616" y="95707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206752" y="1996440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graphicFrame>
        <p:nvGraphicFramePr>
          <p:cNvPr id="20" name="Chart 19"/>
          <p:cNvGraphicFramePr>
            <a:graphicFrameLocks/>
          </p:cNvGraphicFramePr>
          <p:nvPr/>
        </p:nvGraphicFramePr>
        <p:xfrm>
          <a:off x="2834639" y="347472"/>
          <a:ext cx="275748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4629912" y="65227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959096" y="1630680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graphicFrame>
        <p:nvGraphicFramePr>
          <p:cNvPr id="23" name="Chart 22"/>
          <p:cNvGraphicFramePr>
            <a:graphicFrameLocks/>
          </p:cNvGraphicFramePr>
          <p:nvPr/>
        </p:nvGraphicFramePr>
        <p:xfrm>
          <a:off x="5582601" y="356616"/>
          <a:ext cx="27622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7376160" y="1309229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656576" y="2010269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graphicFrame>
        <p:nvGraphicFramePr>
          <p:cNvPr id="25" name="Chart 24"/>
          <p:cNvGraphicFramePr>
            <a:graphicFrameLocks/>
          </p:cNvGraphicFramePr>
          <p:nvPr/>
        </p:nvGraphicFramePr>
        <p:xfrm>
          <a:off x="72389" y="3218688"/>
          <a:ext cx="27622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6" name="TextBox 25"/>
          <p:cNvSpPr txBox="1"/>
          <p:nvPr/>
        </p:nvSpPr>
        <p:spPr>
          <a:xfrm>
            <a:off x="1895856" y="425500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graphicFrame>
        <p:nvGraphicFramePr>
          <p:cNvPr id="27" name="Chart 26"/>
          <p:cNvGraphicFramePr>
            <a:graphicFrameLocks/>
          </p:cNvGraphicFramePr>
          <p:nvPr/>
        </p:nvGraphicFramePr>
        <p:xfrm>
          <a:off x="2858452" y="3224897"/>
          <a:ext cx="273367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8" name="TextBox 27"/>
          <p:cNvSpPr txBox="1"/>
          <p:nvPr/>
        </p:nvSpPr>
        <p:spPr>
          <a:xfrm>
            <a:off x="4636008" y="4014216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962144" y="4751832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graphicFrame>
        <p:nvGraphicFramePr>
          <p:cNvPr id="30" name="Chart 29"/>
          <p:cNvGraphicFramePr>
            <a:graphicFrameLocks/>
          </p:cNvGraphicFramePr>
          <p:nvPr/>
        </p:nvGraphicFramePr>
        <p:xfrm>
          <a:off x="5631478" y="3218688"/>
          <a:ext cx="272891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1" name="TextBox 30"/>
          <p:cNvSpPr txBox="1"/>
          <p:nvPr/>
        </p:nvSpPr>
        <p:spPr>
          <a:xfrm>
            <a:off x="7412736" y="379171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729728" y="4584192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2058006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952744" y="6455664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1</a:t>
            </a:r>
          </a:p>
        </p:txBody>
      </p:sp>
      <p:graphicFrame>
        <p:nvGraphicFramePr>
          <p:cNvPr id="33" name="Chart 32"/>
          <p:cNvGraphicFramePr>
            <a:graphicFrameLocks/>
          </p:cNvGraphicFramePr>
          <p:nvPr/>
        </p:nvGraphicFramePr>
        <p:xfrm>
          <a:off x="81914" y="356616"/>
          <a:ext cx="275272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871472" y="1089773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151888" y="1461629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graphicFrame>
        <p:nvGraphicFramePr>
          <p:cNvPr id="35" name="Chart 34"/>
          <p:cNvGraphicFramePr>
            <a:graphicFrameLocks/>
          </p:cNvGraphicFramePr>
          <p:nvPr/>
        </p:nvGraphicFramePr>
        <p:xfrm>
          <a:off x="2834639" y="356616"/>
          <a:ext cx="275272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6" name="TextBox 35"/>
          <p:cNvSpPr txBox="1"/>
          <p:nvPr/>
        </p:nvSpPr>
        <p:spPr>
          <a:xfrm>
            <a:off x="4684776" y="1507349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4895088" y="1324469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graphicFrame>
        <p:nvGraphicFramePr>
          <p:cNvPr id="38" name="Chart 37"/>
          <p:cNvGraphicFramePr>
            <a:graphicFrameLocks/>
          </p:cNvGraphicFramePr>
          <p:nvPr/>
        </p:nvGraphicFramePr>
        <p:xfrm>
          <a:off x="5587364" y="356616"/>
          <a:ext cx="275272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9" name="TextBox 38"/>
          <p:cNvSpPr txBox="1"/>
          <p:nvPr/>
        </p:nvSpPr>
        <p:spPr>
          <a:xfrm>
            <a:off x="7644384" y="1668893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graphicFrame>
        <p:nvGraphicFramePr>
          <p:cNvPr id="40" name="Chart 39"/>
          <p:cNvGraphicFramePr>
            <a:graphicFrameLocks/>
          </p:cNvGraphicFramePr>
          <p:nvPr/>
        </p:nvGraphicFramePr>
        <p:xfrm>
          <a:off x="91439" y="3099816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1" name="TextBox 40"/>
          <p:cNvSpPr txBox="1"/>
          <p:nvPr/>
        </p:nvSpPr>
        <p:spPr>
          <a:xfrm>
            <a:off x="2167128" y="4457813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1926336" y="3732389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7118901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629400" y="6336268"/>
            <a:ext cx="2461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table S1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5099601"/>
              </p:ext>
            </p:extLst>
          </p:nvPr>
        </p:nvGraphicFramePr>
        <p:xfrm>
          <a:off x="994176" y="978490"/>
          <a:ext cx="5248739" cy="470258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339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47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1440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58238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rimary and </a:t>
                      </a:r>
                      <a:br>
                        <a:rPr lang="en-US" sz="1200" dirty="0">
                          <a:effectLst/>
                        </a:rPr>
                      </a:br>
                      <a:r>
                        <a:rPr lang="en-US" sz="1200" dirty="0">
                          <a:effectLst/>
                        </a:rPr>
                        <a:t>complementary</a:t>
                      </a:r>
                      <a:br>
                        <a:rPr lang="en-US" sz="1200" dirty="0">
                          <a:effectLst/>
                        </a:rPr>
                      </a:br>
                      <a:r>
                        <a:rPr lang="en-US" sz="1200" dirty="0">
                          <a:effectLst/>
                        </a:rPr>
                        <a:t>DNA region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equential position</a:t>
                      </a:r>
                      <a:br>
                        <a:rPr lang="en-US" sz="1200">
                          <a:effectLst/>
                        </a:rPr>
                      </a:br>
                      <a:r>
                        <a:rPr lang="en-US" sz="1200">
                          <a:effectLst/>
                        </a:rPr>
                        <a:t>in original DN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VM scor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-valu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E-valu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9435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ctcaagcgca</a:t>
                      </a:r>
                      <a:br>
                        <a:rPr lang="en-US" sz="1200">
                          <a:effectLst/>
                        </a:rPr>
                      </a:br>
                      <a:r>
                        <a:rPr lang="en-US" sz="1200">
                          <a:effectLst/>
                        </a:rPr>
                        <a:t>tgagttcgcg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C00000"/>
                          </a:solidFill>
                          <a:effectLst/>
                        </a:rPr>
                        <a:t>2597-2607</a:t>
                      </a:r>
                      <a:endParaRPr lang="en-US" sz="1100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C00000"/>
                          </a:solidFill>
                          <a:effectLst/>
                        </a:rPr>
                        <a:t>3.2610 </a:t>
                      </a:r>
                      <a:endParaRPr lang="en-US" sz="1100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C00000"/>
                          </a:solidFill>
                          <a:effectLst/>
                        </a:rPr>
                        <a:t>0.001 </a:t>
                      </a:r>
                      <a:endParaRPr lang="en-US" sz="1100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C00000"/>
                          </a:solidFill>
                          <a:effectLst/>
                        </a:rPr>
                        <a:t>3.113 </a:t>
                      </a:r>
                      <a:endParaRPr lang="en-US" sz="1100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9435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atgcagggac</a:t>
                      </a:r>
                      <a:br>
                        <a:rPr lang="en-US" sz="1200">
                          <a:effectLst/>
                        </a:rPr>
                      </a:br>
                      <a:r>
                        <a:rPr lang="en-US" sz="1200">
                          <a:effectLst/>
                        </a:rPr>
                        <a:t>ctacgtccct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30-24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.0503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0.002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1.829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9435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ctcaaggggg</a:t>
                      </a:r>
                      <a:br>
                        <a:rPr lang="en-US" sz="1200">
                          <a:effectLst/>
                        </a:rPr>
                      </a:br>
                      <a:r>
                        <a:rPr lang="en-US" sz="1200">
                          <a:effectLst/>
                        </a:rPr>
                        <a:t>agagttccccc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887-89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.0270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0.002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1.829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9435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ctgctgtaag</a:t>
                      </a:r>
                      <a:br>
                        <a:rPr lang="en-US" sz="1200">
                          <a:effectLst/>
                        </a:rPr>
                      </a:br>
                      <a:r>
                        <a:rPr lang="en-US" sz="1200">
                          <a:effectLst/>
                        </a:rPr>
                        <a:t>agacgacattc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673-268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6898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0.003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1.168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9435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tcacagggga</a:t>
                      </a:r>
                      <a:br>
                        <a:rPr lang="en-US" sz="1200">
                          <a:effectLst/>
                        </a:rPr>
                      </a:br>
                      <a:r>
                        <a:rPr lang="en-US" sz="1200">
                          <a:effectLst/>
                        </a:rPr>
                        <a:t>gagtgtcccc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901-91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6557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0.004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2.414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9435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tcccttcatt</a:t>
                      </a:r>
                      <a:br>
                        <a:rPr lang="en-US" sz="1200">
                          <a:effectLst/>
                        </a:rPr>
                      </a:br>
                      <a:r>
                        <a:rPr lang="en-US" sz="1200">
                          <a:effectLst/>
                        </a:rPr>
                        <a:t>gagggaagta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874-188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5968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0.004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3.659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9435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gccttggagt</a:t>
                      </a:r>
                      <a:br>
                        <a:rPr lang="en-US" sz="1200">
                          <a:effectLst/>
                        </a:rPr>
                      </a:br>
                      <a:r>
                        <a:rPr lang="en-US" sz="1200">
                          <a:effectLst/>
                        </a:rPr>
                        <a:t>ccggaacctc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369-237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5750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0.004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4.281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9435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ctgcacctgt</a:t>
                      </a:r>
                      <a:br>
                        <a:rPr lang="en-US" sz="1200">
                          <a:effectLst/>
                        </a:rPr>
                      </a:br>
                      <a:r>
                        <a:rPr lang="en-US" sz="1200">
                          <a:effectLst/>
                        </a:rPr>
                        <a:t>cgacgtggac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71-38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4920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0.004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4.904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9435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tccctgaaag</a:t>
                      </a:r>
                      <a:br>
                        <a:rPr lang="en-US" sz="1200">
                          <a:effectLst/>
                        </a:rPr>
                      </a:br>
                      <a:r>
                        <a:rPr lang="en-US" sz="1200">
                          <a:effectLst/>
                        </a:rPr>
                        <a:t>aagggactttc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918-192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3594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0.004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6.772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9435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atgcagcagg</a:t>
                      </a:r>
                      <a:br>
                        <a:rPr lang="en-US" sz="1200">
                          <a:effectLst/>
                        </a:rPr>
                      </a:br>
                      <a:r>
                        <a:rPr lang="en-US" sz="1200">
                          <a:effectLst/>
                        </a:rPr>
                        <a:t>gtacgtcgtcc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692-7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3218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0.004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8.017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51" marR="9151" marT="9151" marB="9151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928354" y="457200"/>
            <a:ext cx="53200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XCR1 promoter: top 10 MYT1L-binding DNA regions scored by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inear SVM </a:t>
            </a:r>
          </a:p>
        </p:txBody>
      </p:sp>
    </p:spTree>
    <p:extLst>
      <p:ext uri="{BB962C8B-B14F-4D97-AF65-F5344CB8AC3E}">
        <p14:creationId xmlns:p14="http://schemas.microsoft.com/office/powerpoint/2010/main" val="9081485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5" t="4232" b="4809"/>
          <a:stretch/>
        </p:blipFill>
        <p:spPr>
          <a:xfrm>
            <a:off x="490538" y="1335880"/>
            <a:ext cx="3548062" cy="250745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0" t="4232" b="4809"/>
          <a:stretch/>
        </p:blipFill>
        <p:spPr>
          <a:xfrm>
            <a:off x="4993480" y="1335880"/>
            <a:ext cx="3540919" cy="250745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019800" y="6324600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S2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07330" y="1094601"/>
            <a:ext cx="21814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 Narrow" panose="020B0606020202030204" pitchFamily="34" charset="0"/>
                <a:cs typeface="Arial" panose="020B0604020202020204" pitchFamily="34" charset="0"/>
              </a:rPr>
              <a:t>Glioblastoma (Project: TCGA-GBM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962961" y="3810000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XCR1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50094" y="2416107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YT1L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029200" y="1066800"/>
            <a:ext cx="24073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 Narrow" panose="020B0606020202030204" pitchFamily="34" charset="0"/>
                <a:cs typeface="Arial" panose="020B0604020202020204" pitchFamily="34" charset="0"/>
              </a:rPr>
              <a:t>Neuroblastoma (Project: TARGET-NBL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513200" y="3810000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XCR1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4545894" y="2388306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YT1L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6200" y="9568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620858" y="9568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304827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030380"/>
              </p:ext>
            </p:extLst>
          </p:nvPr>
        </p:nvGraphicFramePr>
        <p:xfrm>
          <a:off x="1524000" y="1630680"/>
          <a:ext cx="5029200" cy="1112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95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95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FC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T1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95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59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480455" y="914400"/>
            <a:ext cx="530134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S2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ene expression profiling: Differential expression of CXCR1 ligands in HEK293 cells stably expressing MYT1L or GFP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477000" y="6324600"/>
            <a:ext cx="25280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table S2. </a:t>
            </a:r>
          </a:p>
        </p:txBody>
      </p:sp>
    </p:spTree>
    <p:extLst>
      <p:ext uri="{BB962C8B-B14F-4D97-AF65-F5344CB8AC3E}">
        <p14:creationId xmlns:p14="http://schemas.microsoft.com/office/powerpoint/2010/main" val="4553441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019800" y="6324600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S3</a:t>
            </a:r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5270053"/>
              </p:ext>
            </p:extLst>
          </p:nvPr>
        </p:nvGraphicFramePr>
        <p:xfrm>
          <a:off x="381000" y="685800"/>
          <a:ext cx="277177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8874261"/>
              </p:ext>
            </p:extLst>
          </p:nvPr>
        </p:nvGraphicFramePr>
        <p:xfrm>
          <a:off x="3171063" y="697992"/>
          <a:ext cx="271938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9407550"/>
              </p:ext>
            </p:extLst>
          </p:nvPr>
        </p:nvGraphicFramePr>
        <p:xfrm>
          <a:off x="5890451" y="697992"/>
          <a:ext cx="278606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5181600" y="1143000"/>
            <a:ext cx="3337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#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362200" y="1066800"/>
            <a:ext cx="436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 </a:t>
            </a:r>
          </a:p>
        </p:txBody>
      </p:sp>
    </p:spTree>
    <p:extLst>
      <p:ext uri="{BB962C8B-B14F-4D97-AF65-F5344CB8AC3E}">
        <p14:creationId xmlns:p14="http://schemas.microsoft.com/office/powerpoint/2010/main" val="2923731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 preferRelativeResize="0">
            <a:picLocks/>
          </p:cNvPicPr>
          <p:nvPr/>
        </p:nvPicPr>
        <p:blipFill rotWithShape="1">
          <a:blip r:embed="rId2"/>
          <a:srcRect l="35807" t="36539" r="17970" b="30769"/>
          <a:stretch/>
        </p:blipFill>
        <p:spPr>
          <a:xfrm>
            <a:off x="3697299" y="2666997"/>
            <a:ext cx="731520" cy="36576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419600" y="2618599"/>
            <a:ext cx="9509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NA-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Kc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45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3698825" y="1911825"/>
            <a:ext cx="58702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25000"/>
              </a:lnSpc>
            </a:pPr>
            <a:r>
              <a:rPr lang="en-US" sz="1200" dirty="0">
                <a:latin typeface="Arial Narrow" panose="020B0606020202030204" pitchFamily="34" charset="0"/>
                <a:cs typeface="Arial" panose="020B0604020202020204" pitchFamily="34" charset="0"/>
              </a:rPr>
              <a:t>M059J</a:t>
            </a:r>
          </a:p>
          <a:p>
            <a:pPr>
              <a:lnSpc>
                <a:spcPct val="225000"/>
              </a:lnSpc>
            </a:pPr>
            <a:r>
              <a:rPr lang="en-US" sz="1200" dirty="0">
                <a:latin typeface="Arial Narrow" panose="020B0606020202030204" pitchFamily="34" charset="0"/>
                <a:cs typeface="Arial" panose="020B0604020202020204" pitchFamily="34" charset="0"/>
              </a:rPr>
              <a:t>M059K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419600" y="3200400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486400" y="6019800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S4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38736" t="46486" r="44636" b="38701"/>
          <a:stretch/>
        </p:blipFill>
        <p:spPr>
          <a:xfrm>
            <a:off x="3697299" y="3080264"/>
            <a:ext cx="731520" cy="4650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6810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54FBA60-4D33-DFBF-EDF5-5E64689F3F2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4692F490-3E63-858B-67D2-54454982A508}"/>
              </a:ext>
            </a:extLst>
          </p:cNvPr>
          <p:cNvSpPr txBox="1"/>
          <p:nvPr/>
        </p:nvSpPr>
        <p:spPr>
          <a:xfrm>
            <a:off x="5486400" y="6019800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S5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BD5248A-2699-3D37-EBC1-C7DA0ABDA51D}"/>
              </a:ext>
            </a:extLst>
          </p:cNvPr>
          <p:cNvSpPr/>
          <p:nvPr/>
        </p:nvSpPr>
        <p:spPr>
          <a:xfrm>
            <a:off x="2090928" y="2154936"/>
            <a:ext cx="1950212" cy="38709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Loss-of-function study: siRNA-mediated MYT1L knockdown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9D91EE7-2579-D99B-7BA6-B1882FB2675F}"/>
              </a:ext>
            </a:extLst>
          </p:cNvPr>
          <p:cNvSpPr/>
          <p:nvPr/>
        </p:nvSpPr>
        <p:spPr>
          <a:xfrm>
            <a:off x="4285996" y="2154936"/>
            <a:ext cx="2041651" cy="38709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Gain-of-function study: Ectopic MYT1L stable expression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0E67529-DAE2-6953-3B44-36272F352347}"/>
              </a:ext>
            </a:extLst>
          </p:cNvPr>
          <p:cNvSpPr/>
          <p:nvPr/>
        </p:nvSpPr>
        <p:spPr>
          <a:xfrm>
            <a:off x="2081784" y="1335024"/>
            <a:ext cx="4236720" cy="41757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Glioblastoma cell lines used in this study: A172 and M059K with normal DNA-PK activity, M059J with deficient DNA-PK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54FBFCED-9CA6-9688-4305-64A14B3BEDF5}"/>
              </a:ext>
            </a:extLst>
          </p:cNvPr>
          <p:cNvCxnSpPr/>
          <p:nvPr/>
        </p:nvCxnSpPr>
        <p:spPr>
          <a:xfrm flipH="1">
            <a:off x="2697480" y="1798320"/>
            <a:ext cx="0" cy="3230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D155E849-6DA5-807B-2608-21BFEDFAD971}"/>
              </a:ext>
            </a:extLst>
          </p:cNvPr>
          <p:cNvCxnSpPr/>
          <p:nvPr/>
        </p:nvCxnSpPr>
        <p:spPr>
          <a:xfrm flipH="1">
            <a:off x="5785104" y="1813560"/>
            <a:ext cx="0" cy="3230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CF817007-A92D-CBA9-020C-E792369A1D38}"/>
              </a:ext>
            </a:extLst>
          </p:cNvPr>
          <p:cNvSpPr/>
          <p:nvPr/>
        </p:nvSpPr>
        <p:spPr>
          <a:xfrm>
            <a:off x="2087880" y="2926080"/>
            <a:ext cx="4236720" cy="41757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Phenotypic changes in proliferation, apoptosis, and cell cycle and identification of  contributing molecules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16EC6334-9E37-237A-7753-7B7094CD1C09}"/>
              </a:ext>
            </a:extLst>
          </p:cNvPr>
          <p:cNvCxnSpPr/>
          <p:nvPr/>
        </p:nvCxnSpPr>
        <p:spPr>
          <a:xfrm flipH="1">
            <a:off x="2694432" y="2566416"/>
            <a:ext cx="0" cy="3230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A701A474-467A-8370-4CB2-9C82B572417E}"/>
              </a:ext>
            </a:extLst>
          </p:cNvPr>
          <p:cNvCxnSpPr/>
          <p:nvPr/>
        </p:nvCxnSpPr>
        <p:spPr>
          <a:xfrm flipH="1">
            <a:off x="5785104" y="2566416"/>
            <a:ext cx="0" cy="3230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Rectangle 15">
            <a:extLst>
              <a:ext uri="{FF2B5EF4-FFF2-40B4-BE49-F238E27FC236}">
                <a16:creationId xmlns:a16="http://schemas.microsoft.com/office/drawing/2014/main" id="{9F9B972A-5F38-129A-2B31-2F3E638D2C6D}"/>
              </a:ext>
            </a:extLst>
          </p:cNvPr>
          <p:cNvSpPr/>
          <p:nvPr/>
        </p:nvSpPr>
        <p:spPr>
          <a:xfrm>
            <a:off x="2093976" y="3755136"/>
            <a:ext cx="4236720" cy="41757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Global messenger RNA expression profiling and identification of candidate genes of MYT1L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118BE2C-C281-7271-DB2F-3460C52E34C9}"/>
              </a:ext>
            </a:extLst>
          </p:cNvPr>
          <p:cNvSpPr/>
          <p:nvPr/>
        </p:nvSpPr>
        <p:spPr>
          <a:xfrm>
            <a:off x="2090928" y="4593336"/>
            <a:ext cx="4236720" cy="41757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Validation by real-time </a:t>
            </a:r>
            <a:r>
              <a:rPr lang="en-US" sz="1200" dirty="0" err="1">
                <a:solidFill>
                  <a:schemeClr val="tx1"/>
                </a:solidFill>
                <a:latin typeface="Arial Narrow" panose="020B0606020202030204" pitchFamily="34" charset="0"/>
              </a:rPr>
              <a:t>qRT</a:t>
            </a: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PCR, immunofluorescence staining, Western blotting, luciferase assay, siRNA-mediated knockdown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27847D85-FBC4-003F-30EE-CE55A01FEF7D}"/>
              </a:ext>
            </a:extLst>
          </p:cNvPr>
          <p:cNvCxnSpPr/>
          <p:nvPr/>
        </p:nvCxnSpPr>
        <p:spPr>
          <a:xfrm flipH="1">
            <a:off x="4181856" y="3386328"/>
            <a:ext cx="0" cy="3230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B01F2F36-6530-257B-C4A3-5BF1CE9EB47A}"/>
              </a:ext>
            </a:extLst>
          </p:cNvPr>
          <p:cNvCxnSpPr/>
          <p:nvPr/>
        </p:nvCxnSpPr>
        <p:spPr>
          <a:xfrm flipH="1">
            <a:off x="4178808" y="4224528"/>
            <a:ext cx="0" cy="3230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813295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429</Words>
  <Application>Microsoft Office PowerPoint</Application>
  <PresentationFormat>On-screen Show (4:3)</PresentationFormat>
  <Paragraphs>167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Arial Narrow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Lethbrid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Youli’s paper</dc:title>
  <dc:creator>bo.wang5</dc:creator>
  <cp:lastModifiedBy>Kovalchuk, Igor</cp:lastModifiedBy>
  <cp:revision>1175</cp:revision>
  <cp:lastPrinted>2018-06-15T17:14:30Z</cp:lastPrinted>
  <dcterms:created xsi:type="dcterms:W3CDTF">2015-09-30T00:56:30Z</dcterms:created>
  <dcterms:modified xsi:type="dcterms:W3CDTF">2025-01-16T20:35:10Z</dcterms:modified>
</cp:coreProperties>
</file>